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CC159FA-F2AA-4989-A8EB-24DDC2E3ADC7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1F83D13-4C71-4BB3-A4E0-8273CA7CAE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657A26A-69BD-4B96-A6EE-D109922A1A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30155BB-C75E-430A-B130-A494137BF93C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4645D78-CBA2-4D4F-BD93-C499E65196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CB4F0EE-8922-4B0A-8CB2-77E3F809D4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2D2AC28-208F-47A3-926A-A1116A9567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061F387-F07C-44E4-A76B-D234CE7D80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D4996AE-F592-42AE-ACBE-A7A809F287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BA2B196-D9CF-43B1-9DF3-798F7E2514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390EDD8-4251-4A4F-9B62-7372790D39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6706B83-AEE3-4C2B-B26B-7E3BA7FEBE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6/27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2D699047-805E-4384-9A9E-EDAEB222D7E1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233360" y="2916360"/>
            <a:ext cx="4248360" cy="45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Table S1 RNA integrity number (RIN) used for qRT-PCR analysi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233360" y="3440160"/>
            <a:ext cx="4175280" cy="144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417680" y="4289400"/>
            <a:ext cx="383868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T-PCR       7.3±0.1           8.3±0.2         7.6±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455920" y="3906720"/>
            <a:ext cx="247644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L                  SEL                S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239920" y="3838680"/>
            <a:ext cx="2809800" cy="144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160800" y="3506760"/>
            <a:ext cx="99360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Tissue 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249200" y="4697280"/>
            <a:ext cx="4175280" cy="180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249200" y="4697280"/>
            <a:ext cx="439128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Values are the means ± s.e. of three biological replication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239920" y="4191120"/>
            <a:ext cx="2809800" cy="144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